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7" r:id="rId2"/>
  </p:sldIdLst>
  <p:sldSz cx="12192000" cy="7772400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40445"/>
    <a:srgbClr val="3C1C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 autoAdjust="0"/>
    <p:restoredTop sz="98287" autoAdjust="0"/>
  </p:normalViewPr>
  <p:slideViewPr>
    <p:cSldViewPr snapToGrid="0">
      <p:cViewPr>
        <p:scale>
          <a:sx n="70" d="100"/>
          <a:sy n="70" d="100"/>
        </p:scale>
        <p:origin x="-1099" y="-413"/>
      </p:cViewPr>
      <p:guideLst>
        <p:guide orient="horz" pos="2449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ABE69-1E0A-4574-A649-E0734A7515EE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744538"/>
            <a:ext cx="5840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40363" cy="44688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21F534-534B-4480-8E10-8B09B761BC8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140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72013"/>
            <a:ext cx="9144000" cy="270594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82311"/>
            <a:ext cx="9144000" cy="187653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909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08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13811"/>
            <a:ext cx="2628900" cy="658674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13811"/>
            <a:ext cx="7734300" cy="658674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285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59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37703"/>
            <a:ext cx="10515600" cy="323310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201393"/>
            <a:ext cx="10515600" cy="1700212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195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068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13809"/>
            <a:ext cx="10515600" cy="150230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2" y="1905320"/>
            <a:ext cx="51577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2" y="2839085"/>
            <a:ext cx="51577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05320"/>
            <a:ext cx="51831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39085"/>
            <a:ext cx="51831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01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560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5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0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413809"/>
            <a:ext cx="10515600" cy="15023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2069043"/>
            <a:ext cx="10515600" cy="49315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7203863"/>
            <a:ext cx="41148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043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5" name="Group 3074"/>
          <p:cNvGrpSpPr/>
          <p:nvPr/>
        </p:nvGrpSpPr>
        <p:grpSpPr>
          <a:xfrm>
            <a:off x="-54430" y="685799"/>
            <a:ext cx="12246430" cy="5900058"/>
            <a:chOff x="-54430" y="685799"/>
            <a:chExt cx="12246430" cy="5900058"/>
          </a:xfrm>
        </p:grpSpPr>
        <p:grpSp>
          <p:nvGrpSpPr>
            <p:cNvPr id="2" name="Group 1"/>
            <p:cNvGrpSpPr/>
            <p:nvPr/>
          </p:nvGrpSpPr>
          <p:grpSpPr>
            <a:xfrm>
              <a:off x="1" y="685799"/>
              <a:ext cx="12191999" cy="5900058"/>
              <a:chOff x="521117" y="685799"/>
              <a:chExt cx="10561565" cy="4430487"/>
            </a:xfrm>
          </p:grpSpPr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8852"/>
              <a:stretch/>
            </p:blipFill>
            <p:spPr bwMode="auto">
              <a:xfrm>
                <a:off x="521117" y="685799"/>
                <a:ext cx="10561565" cy="44304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" name="TextBox 2"/>
              <p:cNvSpPr txBox="1"/>
              <p:nvPr/>
            </p:nvSpPr>
            <p:spPr>
              <a:xfrm rot="16200000">
                <a:off x="749615" y="2559593"/>
                <a:ext cx="104150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A 2039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TextBox 3"/>
              <p:cNvSpPr txBox="1"/>
              <p:nvPr/>
            </p:nvSpPr>
            <p:spPr>
              <a:xfrm rot="16200000">
                <a:off x="1053538" y="2569596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B 2039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 rot="16200000">
                <a:off x="1443914" y="2602297"/>
                <a:ext cx="112691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L 87119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 rot="16200000">
                <a:off x="2251623" y="2559593"/>
                <a:ext cx="104150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A 2089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16200000">
                <a:off x="2546680" y="2569596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B 2089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16200000">
                <a:off x="2947974" y="2569596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R 3637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6200000">
                <a:off x="3634175" y="2559593"/>
                <a:ext cx="104150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A 2078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6200000">
                <a:off x="3994514" y="2569595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B 2078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6200000">
                <a:off x="4383232" y="2569595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R 4395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5127259" y="2559593"/>
                <a:ext cx="104150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A 2043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5431462" y="2569596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B 2043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5798442" y="2569596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R 3473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 rot="16200000">
                <a:off x="6575093" y="2559593"/>
                <a:ext cx="104150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A 2047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6872868" y="2569596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B 2047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6200000">
                <a:off x="7182617" y="2569596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R 2740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6200000">
                <a:off x="7659113" y="2559593"/>
                <a:ext cx="104150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A 2048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 rot="16200000">
                <a:off x="7956888" y="2569595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B 2048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16200000">
                <a:off x="8264665" y="2569595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R 3494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6200000">
                <a:off x="9097668" y="2559593"/>
                <a:ext cx="104150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A 2092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9467106" y="2569595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B 2092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9774883" y="2569595"/>
                <a:ext cx="106150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IN" sz="1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CPR 3762</a:t>
                </a:r>
                <a:endPara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Rectangle 26"/>
            <p:cNvSpPr/>
            <p:nvPr/>
          </p:nvSpPr>
          <p:spPr>
            <a:xfrm>
              <a:off x="0" y="4319414"/>
              <a:ext cx="13035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LG08_RFQI1</a:t>
              </a:r>
            </a:p>
          </p:txBody>
        </p:sp>
        <p:sp>
          <p:nvSpPr>
            <p:cNvPr id="28" name="Rectangle 27"/>
            <p:cNvSpPr/>
            <p:nvPr/>
          </p:nvSpPr>
          <p:spPr>
            <a:xfrm>
              <a:off x="-54430" y="5057150"/>
              <a:ext cx="13035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12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cLG08_RFQI4</a:t>
              </a:r>
              <a:endParaRPr lang="en-I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Elbow Connector 28"/>
            <p:cNvCxnSpPr/>
            <p:nvPr/>
          </p:nvCxnSpPr>
          <p:spPr>
            <a:xfrm flipV="1">
              <a:off x="195943" y="4898572"/>
              <a:ext cx="401408" cy="158578"/>
            </a:xfrm>
            <a:prstGeom prst="bentConnector3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Elbow Connector 30"/>
            <p:cNvCxnSpPr/>
            <p:nvPr/>
          </p:nvCxnSpPr>
          <p:spPr>
            <a:xfrm>
              <a:off x="195943" y="4596413"/>
              <a:ext cx="401407" cy="84443"/>
            </a:xfrm>
            <a:prstGeom prst="bentConnector3">
              <a:avLst>
                <a:gd name="adj1" fmla="val 50000"/>
              </a:avLst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664669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2</TotalTime>
  <Words>44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Saxena, Rachit (ICRISAT-IN)</cp:lastModifiedBy>
  <cp:revision>158</cp:revision>
  <dcterms:created xsi:type="dcterms:W3CDTF">2014-11-24T17:11:55Z</dcterms:created>
  <dcterms:modified xsi:type="dcterms:W3CDTF">2016-08-01T03:52:02Z</dcterms:modified>
</cp:coreProperties>
</file>